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403FB62-18AF-1B75-9AD7-2BA605679B25}" v="6" dt="2021-09-30T08:18:43.4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60" d="100"/>
          <a:sy n="160" d="100"/>
        </p:scale>
        <p:origin x="26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0D324A5B-97C9-47D7-A832-F8B4F9BB6493}" type="doc">
      <dgm:prSet loTypeId="urn:microsoft.com/office/officeart/2005/8/layout/venn1" loCatId="relationship" qsTypeId="urn:microsoft.com/office/officeart/2005/8/quickstyle/simple1" qsCatId="simple" csTypeId="urn:microsoft.com/office/officeart/2005/8/colors/accent1_2" csCatId="accent1" phldr="1"/>
      <dgm:spPr/>
    </dgm:pt>
    <dgm:pt modelId="{18C9835F-7C17-4B0C-833A-7C198B164125}">
      <dgm:prSet phldrT="[Text]" custT="1"/>
      <dgm:spPr/>
      <dgm:t>
        <a:bodyPr/>
        <a:lstStyle/>
        <a:p>
          <a:endParaRPr lang="en-US" sz="6500" dirty="0"/>
        </a:p>
      </dgm:t>
    </dgm:pt>
    <dgm:pt modelId="{41866846-B82E-41EB-9A7D-8FFD49B6B4B2}" type="parTrans" cxnId="{3F8EFA90-089E-4310-857D-A69DF58B54B2}">
      <dgm:prSet/>
      <dgm:spPr/>
      <dgm:t>
        <a:bodyPr/>
        <a:lstStyle/>
        <a:p>
          <a:endParaRPr lang="en-US"/>
        </a:p>
      </dgm:t>
    </dgm:pt>
    <dgm:pt modelId="{D60626B5-F860-4F82-8BE6-4273A6C37A6D}" type="sibTrans" cxnId="{3F8EFA90-089E-4310-857D-A69DF58B54B2}">
      <dgm:prSet/>
      <dgm:spPr/>
      <dgm:t>
        <a:bodyPr/>
        <a:lstStyle/>
        <a:p>
          <a:endParaRPr lang="en-US"/>
        </a:p>
      </dgm:t>
    </dgm:pt>
    <dgm:pt modelId="{FA337DAA-7A9D-410C-A433-34F685A4DDE2}">
      <dgm:prSet phldrT="[Text]" custT="1"/>
      <dgm:spPr/>
      <dgm:t>
        <a:bodyPr/>
        <a:lstStyle/>
        <a:p>
          <a:endParaRPr lang="en-US" sz="6500" dirty="0"/>
        </a:p>
      </dgm:t>
    </dgm:pt>
    <dgm:pt modelId="{66AC3DD1-6A81-4D02-AE8B-1194EA07CB16}" type="parTrans" cxnId="{51A44175-3528-48FD-B7A8-650D00840DDB}">
      <dgm:prSet/>
      <dgm:spPr/>
      <dgm:t>
        <a:bodyPr/>
        <a:lstStyle/>
        <a:p>
          <a:endParaRPr lang="en-US"/>
        </a:p>
      </dgm:t>
    </dgm:pt>
    <dgm:pt modelId="{226CF9D3-51B3-493A-88DF-514FC0BFE28E}" type="sibTrans" cxnId="{51A44175-3528-48FD-B7A8-650D00840DDB}">
      <dgm:prSet/>
      <dgm:spPr/>
      <dgm:t>
        <a:bodyPr/>
        <a:lstStyle/>
        <a:p>
          <a:endParaRPr lang="en-US"/>
        </a:p>
      </dgm:t>
    </dgm:pt>
    <dgm:pt modelId="{84486358-8440-45BE-84F5-71FBA56718FA}" type="pres">
      <dgm:prSet presAssocID="{0D324A5B-97C9-47D7-A832-F8B4F9BB6493}" presName="compositeShape" presStyleCnt="0">
        <dgm:presLayoutVars>
          <dgm:chMax val="7"/>
          <dgm:dir/>
          <dgm:resizeHandles val="exact"/>
        </dgm:presLayoutVars>
      </dgm:prSet>
      <dgm:spPr/>
    </dgm:pt>
    <dgm:pt modelId="{116F6866-196C-401E-9FBC-A58C268A2338}" type="pres">
      <dgm:prSet presAssocID="{18C9835F-7C17-4B0C-833A-7C198B164125}" presName="circ1" presStyleLbl="vennNode1" presStyleIdx="0" presStyleCnt="2" custScaleX="53720" custScaleY="53720" custLinFactNeighborX="-8729" custLinFactNeighborY="-15831"/>
      <dgm:spPr/>
    </dgm:pt>
    <dgm:pt modelId="{1272D0C1-3713-40DB-B825-ADFDD6E2002B}" type="pres">
      <dgm:prSet presAssocID="{18C9835F-7C17-4B0C-833A-7C198B164125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1B5CFC21-1F17-443E-B670-82D682043D8D}" type="pres">
      <dgm:prSet presAssocID="{FA337DAA-7A9D-410C-A433-34F685A4DDE2}" presName="circ2" presStyleLbl="vennNode1" presStyleIdx="1" presStyleCnt="2" custScaleX="69022" custScaleY="69022" custLinFactNeighborX="-50435" custLinFactNeighborY="-14799"/>
      <dgm:spPr/>
    </dgm:pt>
    <dgm:pt modelId="{11BA1F6F-91F3-45BA-BD68-6EBCA35CC696}" type="pres">
      <dgm:prSet presAssocID="{FA337DAA-7A9D-410C-A433-34F685A4DDE2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83104864-21F1-42A6-8F58-DF28EBC2D2A6}" type="presOf" srcId="{18C9835F-7C17-4B0C-833A-7C198B164125}" destId="{116F6866-196C-401E-9FBC-A58C268A2338}" srcOrd="0" destOrd="0" presId="urn:microsoft.com/office/officeart/2005/8/layout/venn1"/>
    <dgm:cxn modelId="{B8EE9473-3D7D-46A9-AFF9-4C679495C316}" type="presOf" srcId="{18C9835F-7C17-4B0C-833A-7C198B164125}" destId="{1272D0C1-3713-40DB-B825-ADFDD6E2002B}" srcOrd="1" destOrd="0" presId="urn:microsoft.com/office/officeart/2005/8/layout/venn1"/>
    <dgm:cxn modelId="{51A44175-3528-48FD-B7A8-650D00840DDB}" srcId="{0D324A5B-97C9-47D7-A832-F8B4F9BB6493}" destId="{FA337DAA-7A9D-410C-A433-34F685A4DDE2}" srcOrd="1" destOrd="0" parTransId="{66AC3DD1-6A81-4D02-AE8B-1194EA07CB16}" sibTransId="{226CF9D3-51B3-493A-88DF-514FC0BFE28E}"/>
    <dgm:cxn modelId="{3F8EFA90-089E-4310-857D-A69DF58B54B2}" srcId="{0D324A5B-97C9-47D7-A832-F8B4F9BB6493}" destId="{18C9835F-7C17-4B0C-833A-7C198B164125}" srcOrd="0" destOrd="0" parTransId="{41866846-B82E-41EB-9A7D-8FFD49B6B4B2}" sibTransId="{D60626B5-F860-4F82-8BE6-4273A6C37A6D}"/>
    <dgm:cxn modelId="{AC8477B0-FC91-4FED-8450-BFE50AFB6BE9}" type="presOf" srcId="{0D324A5B-97C9-47D7-A832-F8B4F9BB6493}" destId="{84486358-8440-45BE-84F5-71FBA56718FA}" srcOrd="0" destOrd="0" presId="urn:microsoft.com/office/officeart/2005/8/layout/venn1"/>
    <dgm:cxn modelId="{8D4271E7-464F-45ED-8409-1878FC279BB9}" type="presOf" srcId="{FA337DAA-7A9D-410C-A433-34F685A4DDE2}" destId="{11BA1F6F-91F3-45BA-BD68-6EBCA35CC696}" srcOrd="1" destOrd="0" presId="urn:microsoft.com/office/officeart/2005/8/layout/venn1"/>
    <dgm:cxn modelId="{0F5ACDF1-835E-4F73-9105-0C95835F2A9C}" type="presOf" srcId="{FA337DAA-7A9D-410C-A433-34F685A4DDE2}" destId="{1B5CFC21-1F17-443E-B670-82D682043D8D}" srcOrd="0" destOrd="0" presId="urn:microsoft.com/office/officeart/2005/8/layout/venn1"/>
    <dgm:cxn modelId="{CD482619-E372-436F-A248-266BD0993C1F}" type="presParOf" srcId="{84486358-8440-45BE-84F5-71FBA56718FA}" destId="{116F6866-196C-401E-9FBC-A58C268A2338}" srcOrd="0" destOrd="0" presId="urn:microsoft.com/office/officeart/2005/8/layout/venn1"/>
    <dgm:cxn modelId="{19489AFC-A77C-48D5-BF5B-683847F5BEFA}" type="presParOf" srcId="{84486358-8440-45BE-84F5-71FBA56718FA}" destId="{1272D0C1-3713-40DB-B825-ADFDD6E2002B}" srcOrd="1" destOrd="0" presId="urn:microsoft.com/office/officeart/2005/8/layout/venn1"/>
    <dgm:cxn modelId="{34455DAA-2605-4D9D-90FE-F0F40FEABD21}" type="presParOf" srcId="{84486358-8440-45BE-84F5-71FBA56718FA}" destId="{1B5CFC21-1F17-443E-B670-82D682043D8D}" srcOrd="2" destOrd="0" presId="urn:microsoft.com/office/officeart/2005/8/layout/venn1"/>
    <dgm:cxn modelId="{1EE817B4-A36A-4867-8024-4D4AAB441C9B}" type="presParOf" srcId="{84486358-8440-45BE-84F5-71FBA56718FA}" destId="{11BA1F6F-91F3-45BA-BD68-6EBCA35CC696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16F6866-196C-401E-9FBC-A58C268A2338}">
      <dsp:nvSpPr>
        <dsp:cNvPr id="0" name=""/>
        <dsp:cNvSpPr/>
      </dsp:nvSpPr>
      <dsp:spPr>
        <a:xfrm>
          <a:off x="900227" y="338330"/>
          <a:ext cx="2396985" cy="2396985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6500" kern="1200" dirty="0"/>
        </a:p>
      </dsp:txBody>
      <dsp:txXfrm>
        <a:off x="1234941" y="620986"/>
        <a:ext cx="1382045" cy="1831673"/>
      </dsp:txXfrm>
    </dsp:sp>
    <dsp:sp modelId="{1B5CFC21-1F17-443E-B670-82D682043D8D}">
      <dsp:nvSpPr>
        <dsp:cNvPr id="0" name=""/>
        <dsp:cNvSpPr/>
      </dsp:nvSpPr>
      <dsp:spPr>
        <a:xfrm>
          <a:off x="1913773" y="42990"/>
          <a:ext cx="3079760" cy="3079760"/>
        </a:xfrm>
        <a:prstGeom prst="ellipse">
          <a:avLst/>
        </a:prstGeom>
        <a:solidFill>
          <a:schemeClr val="accen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6500" kern="1200" dirty="0"/>
        </a:p>
      </dsp:txBody>
      <dsp:txXfrm>
        <a:off x="2787759" y="406160"/>
        <a:ext cx="1775718" cy="235342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F66272-8840-447F-9C10-9D5EEA6CA7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18D833-4090-4290-A9C8-E9817FC17A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8FE838-D264-49A3-A625-919B6C37A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5C64B6-8F4B-4F3F-9280-05811861B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1C3DD6-E217-46AD-9F55-194783F00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449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384A95-1F4F-4C69-9721-59C53A6C96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5F1E17-5A77-48AF-B8CD-23A3E4AD69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E0E0D-23DD-442E-AD30-1C640C95D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0E7B6-212C-46B6-B194-267367636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803BAD-A872-4219-AC8F-E0C22D29C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746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8A85E4-522A-4C27-ADF9-EBDF665CCC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E8B22D-5BA1-4709-90A3-B364C96F01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579A0F-EB10-4754-8B32-0C4EBF4C9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B609B7-F374-4D34-88C5-AA6EC4891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AEE95D-64F0-499E-B7F5-0EB2F2170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496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5A0BE9-AC16-45A0-A0DB-7B1DDC3EDC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62B46B-E12E-4E60-87B0-2D004D26C0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5B65D-7387-49FE-AC26-F95CB7ACA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90F76E-3961-45DB-B318-4109950C0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0F23B7-46F1-463A-A4CF-97E51885C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005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3FBBA-1CC6-4CD2-9764-B50749454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C3C34F-9B90-49F5-8CF8-147B78B8D2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215191-B967-4ADB-92FD-7413B7D4A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8370DF-E8F6-4E1B-8D83-84FD7362E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30D10A-DA57-42A8-9553-FAF1156C2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083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5BE3A-CF38-4B19-8021-947486E27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1B3772-237C-4EEB-AE07-0A63DC4330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6E7BA3-A0A0-4608-AE19-6A5D1063BB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ECC6E5-0B04-47D4-9609-C746448C7D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0AB0A6-F7CE-47A6-BB2D-B131BC3C2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D08379-DB2F-43A4-AE3C-72AF85A49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588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EC0E79-9537-4540-937E-588EB684DC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6610EA-538F-4665-938C-AD0BDB978C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0C2F98-C9B2-4BC1-BBF1-4A65BA70A5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B31CCE-C4EF-4552-9FCA-9E6F393756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C8F402-E534-42E0-9EB8-47B0377C96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AB5B66-3BC0-4F73-B180-4B5562550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B980A52-0BFE-4D29-A1CA-2A2FDADE5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20C6DB-F4F2-4221-8D2B-3F31A44B8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408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5B5B8E-1E9C-45FC-96C6-906303A371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3FD70D-88AF-457E-8152-E9A2D2F6E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49B4C7-4A88-4F85-AD54-1D484C234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7E9491A-B533-47AE-9DB7-0C7D2D898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048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7B14C6-C1A4-4F0C-9C53-C16B969BA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B9FEA7-5272-493B-B43C-16577592A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932F7A-7068-4E3A-96F1-EE11B487E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887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CC258F-1C4A-46EE-B2A2-24F34406B2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614D08-CA14-4C41-BC55-DE46A2F3EB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05329A-F6E3-4448-880C-D8BC2DE5D6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CC75FE-895D-429E-920C-89B8D741F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16F0D9-B859-4D5D-BF9F-F180927B1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705DDB-417A-45AF-8600-5839E8DFB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915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31F089-BA81-4118-A369-988868F232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28E5FA-BBD6-45EF-8569-9520BBEFCA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4701EE-00B4-4029-B70E-CBB538F4D0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B499D9-9287-421E-A0E2-4163E6FDD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B11190-20CA-40FD-829A-C9B0C149D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903B11-FEB1-4FA1-9300-A75B9A34B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025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D1C972-E6FC-436D-B1EC-3B83413654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EB8422-BE40-4E80-8397-4B94328907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17645F-6530-4C42-8E9D-777BB802F4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B493C9-3931-4939-9206-9228BBAE1E71}" type="datetimeFigureOut">
              <a:rPr lang="en-US" smtClean="0"/>
              <a:t>9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790022-36CD-46F9-B3AE-3C36D3B520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E16DE1-8728-4D17-B128-BC9721A03F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6C00A8-D726-4A30-9185-6A1A836BAB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955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1C0F054C-4601-4198-9E79-12310B8CCFB3}"/>
              </a:ext>
            </a:extLst>
          </p:cNvPr>
          <p:cNvGrpSpPr/>
          <p:nvPr/>
        </p:nvGrpSpPr>
        <p:grpSpPr>
          <a:xfrm>
            <a:off x="-230641" y="92268"/>
            <a:ext cx="8533659" cy="4486405"/>
            <a:chOff x="-230641" y="92268"/>
            <a:chExt cx="8533659" cy="4486405"/>
          </a:xfrm>
        </p:grpSpPr>
        <p:graphicFrame>
          <p:nvGraphicFramePr>
            <p:cNvPr id="6" name="Diagram 5">
              <a:extLst>
                <a:ext uri="{FF2B5EF4-FFF2-40B4-BE49-F238E27FC236}">
                  <a16:creationId xmlns:a16="http://schemas.microsoft.com/office/drawing/2014/main" id="{1E4E4D02-04D4-41F2-B3FF-66A7FE7BC183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934121224"/>
                </p:ext>
              </p:extLst>
            </p:nvPr>
          </p:nvGraphicFramePr>
          <p:xfrm>
            <a:off x="-230641" y="92268"/>
            <a:ext cx="8533659" cy="4486405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2" r:lo="rId3" r:qs="rId4" r:cs="rId5"/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6C15348-F38C-46AA-8E7A-32B07F843E9F}"/>
                </a:ext>
              </a:extLst>
            </p:cNvPr>
            <p:cNvSpPr txBox="1"/>
            <p:nvPr/>
          </p:nvSpPr>
          <p:spPr>
            <a:xfrm>
              <a:off x="2055643" y="1296817"/>
              <a:ext cx="837644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/>
              <a:r>
                <a:rPr lang="en-US" sz="3200" dirty="0"/>
                <a:t>26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EC267B2-FA4B-45D4-BFE3-58912EAE2BD8}"/>
                </a:ext>
              </a:extLst>
            </p:cNvPr>
            <p:cNvSpPr txBox="1"/>
            <p:nvPr/>
          </p:nvSpPr>
          <p:spPr>
            <a:xfrm>
              <a:off x="3329441" y="1296818"/>
              <a:ext cx="1200288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/>
              <a:r>
                <a:rPr lang="en-US" sz="3200" dirty="0"/>
                <a:t>1052</a:t>
              </a:r>
              <a:endParaRPr lang="en-US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C2716FD-7AD5-4173-9D20-336FF929DA60}"/>
                </a:ext>
              </a:extLst>
            </p:cNvPr>
            <p:cNvSpPr txBox="1"/>
            <p:nvPr/>
          </p:nvSpPr>
          <p:spPr>
            <a:xfrm>
              <a:off x="722882" y="1349846"/>
              <a:ext cx="961120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/>
              <a:r>
                <a:rPr lang="en-US" sz="3200" dirty="0"/>
                <a:t>497</a:t>
              </a:r>
              <a:endParaRPr lang="en-US" dirty="0"/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F816C44C-00CA-4C3C-8D8C-5EA8368C1D39}"/>
              </a:ext>
            </a:extLst>
          </p:cNvPr>
          <p:cNvSpPr txBox="1"/>
          <p:nvPr/>
        </p:nvSpPr>
        <p:spPr>
          <a:xfrm>
            <a:off x="399266" y="3319421"/>
            <a:ext cx="16563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/>
            <a:r>
              <a:rPr lang="en-US" sz="1800" dirty="0"/>
              <a:t>Alkaloid extract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EBCCD2A-1175-40A1-8DAC-A8CAADD3BEF5}"/>
              </a:ext>
            </a:extLst>
          </p:cNvPr>
          <p:cNvSpPr txBox="1"/>
          <p:nvPr/>
        </p:nvSpPr>
        <p:spPr>
          <a:xfrm>
            <a:off x="2755346" y="3319421"/>
            <a:ext cx="21437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/>
            <a:r>
              <a:rPr lang="en-US" sz="1800" dirty="0"/>
              <a:t>Non-alkaloid extract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F6C9F25-9F30-42B1-9FB9-6C6F0D79859C}"/>
              </a:ext>
            </a:extLst>
          </p:cNvPr>
          <p:cNvSpPr txBox="1"/>
          <p:nvPr/>
        </p:nvSpPr>
        <p:spPr>
          <a:xfrm>
            <a:off x="506055" y="3980200"/>
            <a:ext cx="8704690" cy="646331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800" dirty="0"/>
              <a:t>Figure</a:t>
            </a:r>
            <a:r>
              <a:rPr lang="en-US" dirty="0"/>
              <a:t> S:</a:t>
            </a:r>
            <a:r>
              <a:rPr lang="en-US" sz="1800" dirty="0"/>
              <a:t> Venn diagram for the number of features found using HPLC-MSMS in the two extracts, </a:t>
            </a:r>
            <a:r>
              <a:rPr lang="en-US" dirty="0"/>
              <a:t>alkaloids vs non-alkaloids.</a:t>
            </a:r>
          </a:p>
        </p:txBody>
      </p:sp>
    </p:spTree>
    <p:extLst>
      <p:ext uri="{BB962C8B-B14F-4D97-AF65-F5344CB8AC3E}">
        <p14:creationId xmlns:p14="http://schemas.microsoft.com/office/powerpoint/2010/main" val="332615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E809F186-8DD8-4441-BBA8-74EFB64C1A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9988" y="302838"/>
            <a:ext cx="7728617" cy="395034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46C6B40-5D43-4ACF-8C08-3CD9C828BCF6}"/>
              </a:ext>
            </a:extLst>
          </p:cNvPr>
          <p:cNvSpPr txBox="1"/>
          <p:nvPr/>
        </p:nvSpPr>
        <p:spPr>
          <a:xfrm>
            <a:off x="1571951" y="4490015"/>
            <a:ext cx="870469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/>
            <a:r>
              <a:rPr lang="en-US" sz="1800" dirty="0"/>
              <a:t>Figure(X): 3D chromatogram for representative extracts, RED alkaloid extract, BLUE, non-alkaloid extract using 3D visualizer</a:t>
            </a:r>
            <a:r>
              <a:rPr lang="en-US" dirty="0"/>
              <a:t>. X-axis shows retention time, Y-axis shows m/z, Z-axis shows intensity.</a:t>
            </a:r>
          </a:p>
        </p:txBody>
      </p:sp>
    </p:spTree>
    <p:extLst>
      <p:ext uri="{BB962C8B-B14F-4D97-AF65-F5344CB8AC3E}">
        <p14:creationId xmlns:p14="http://schemas.microsoft.com/office/powerpoint/2010/main" val="8831138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67</Words>
  <Application>Microsoft Office PowerPoint</Application>
  <PresentationFormat>Widescreen</PresentationFormat>
  <Paragraphs>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ed Y. Refai</dc:creator>
  <cp:lastModifiedBy>Mohammed Y. Refai</cp:lastModifiedBy>
  <cp:revision>8</cp:revision>
  <dcterms:created xsi:type="dcterms:W3CDTF">2021-09-27T21:30:42Z</dcterms:created>
  <dcterms:modified xsi:type="dcterms:W3CDTF">2021-09-30T08:18:46Z</dcterms:modified>
</cp:coreProperties>
</file>